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oulanger, Lisa M." initials="LMB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>
    <p:restoredLeft sz="12463" autoAdjust="0"/>
    <p:restoredTop sz="89146" autoAdjust="0"/>
  </p:normalViewPr>
  <p:slideViewPr>
    <p:cSldViewPr showGuides="1">
      <p:cViewPr>
        <p:scale>
          <a:sx n="75" d="100"/>
          <a:sy n="75" d="100"/>
        </p:scale>
        <p:origin x="-1512" y="-78"/>
      </p:cViewPr>
      <p:guideLst>
        <p:guide orient="horz" pos="1767"/>
        <p:guide pos="24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9327138" cy="3932713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03310D-168A-4725-986A-1DF8C00AC50E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40FE85-6C64-46EA-8FBB-1A01C2F08E7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62367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igure</a:t>
            </a:r>
            <a:r>
              <a:rPr lang="en-US" baseline="0" dirty="0" smtClean="0"/>
              <a:t> S1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7C2CDE-7128-3E47-90AE-CFB30689CDFD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710301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79348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80359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55376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799021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56586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55915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48147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677732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01818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12892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86811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7EE5D-E7A7-4493-8C73-916ACB1111B2}" type="datetimeFigureOut">
              <a:rPr lang="en-US" smtClean="0"/>
              <a:pPr/>
              <a:t>6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F538AD-C639-4B66-9199-535FAE2B9DE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87488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71162" y="862263"/>
            <a:ext cx="2845651" cy="61863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nfan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10</a:t>
            </a:r>
          </a:p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las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 [ST]X[FWCYMVILA]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2 [YFWCMVILA]X[YFWCMVILA]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3 [DE]X[YFWCMVIL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</a:p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X = any amino acid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nikian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08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1a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[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/R]XSDV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1b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Ω[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/K]ET[S/T/R/K]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1c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ϕ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TXL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1d ETXV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1e TW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Ψ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1f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ΩΩ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W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Ψ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1g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ϕϕ[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/S][T/S]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ΩΨ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1h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ϕ[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/E][T/S]W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Ψ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2a FD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ΩΩ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2b WX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Ω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DV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2c W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Ωϕ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Ψ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2d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ϕ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X[E/D]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ϕϕ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2e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ϕϕϕ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2f [D/E]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Ωϕ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3a W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Ω[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/T]DW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Ψ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4a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Ωϕ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WF</a:t>
            </a:r>
          </a:p>
          <a:p>
            <a:r>
              <a:rPr lang="el-GR" sz="1200" i="1" dirty="0">
                <a:latin typeface="Arial" panose="020B0604020202020204" pitchFamily="34" charset="0"/>
                <a:cs typeface="Arial" panose="020B0604020202020204" pitchFamily="34" charset="0"/>
              </a:rPr>
              <a:t>ϕ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= hydrophobic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(V,I,L,F,W,Y,M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l-GR" sz="1200" i="1" dirty="0">
                <a:latin typeface="Arial" panose="020B0604020202020204" pitchFamily="34" charset="0"/>
                <a:cs typeface="Arial" panose="020B0604020202020204" pitchFamily="34" charset="0"/>
              </a:rPr>
              <a:t>Ω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= aromatic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(F, W,Y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Ψ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= aliphatic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(V, I, L, M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X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= any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mino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ourr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03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1 [ST]X[VLI]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2 [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]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X[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]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lass 3 [DE]X[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ϕ]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l-GR" sz="1200" i="1" dirty="0">
                <a:latin typeface="Arial" panose="020B0604020202020204" pitchFamily="34" charset="0"/>
                <a:cs typeface="Arial" panose="020B0604020202020204" pitchFamily="34" charset="0"/>
              </a:rPr>
              <a:t>ϕ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= hydrophobic (V,I,L,F,Y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6006500" y="8865414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892721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74</TotalTime>
  <Words>174</Words>
  <Application>Microsoft Office PowerPoint</Application>
  <PresentationFormat>On-screen Show (4:3)</PresentationFormat>
  <Paragraphs>3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Princeton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ulanger, Lisa M.</dc:creator>
  <cp:lastModifiedBy>escusana</cp:lastModifiedBy>
  <cp:revision>62</cp:revision>
  <dcterms:created xsi:type="dcterms:W3CDTF">2015-10-27T22:53:08Z</dcterms:created>
  <dcterms:modified xsi:type="dcterms:W3CDTF">2016-05-31T21:54:08Z</dcterms:modified>
</cp:coreProperties>
</file>